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3" autoAdjust="0"/>
    <p:restoredTop sz="94660"/>
  </p:normalViewPr>
  <p:slideViewPr>
    <p:cSldViewPr snapToGrid="0">
      <p:cViewPr>
        <p:scale>
          <a:sx n="66" d="100"/>
          <a:sy n="66" d="100"/>
        </p:scale>
        <p:origin x="444" y="9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98065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42731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138569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000924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91135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476792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55375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101400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45957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31836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881388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356425-6260-46FD-8E16-52C81AE03BAD}" type="datetimeFigureOut">
              <a:rPr lang="ko-KR" altLang="en-US" smtClean="0"/>
              <a:t>2021-07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EE3F93-C93A-4A3A-8282-BC0EB6B5CFC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62492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7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954416" y="434044"/>
            <a:ext cx="2475613" cy="2850772"/>
            <a:chOff x="2645607" y="404664"/>
            <a:chExt cx="2490588" cy="3632993"/>
          </a:xfrm>
        </p:grpSpPr>
        <p:sp>
          <p:nvSpPr>
            <p:cNvPr id="5" name="직사각형 4"/>
            <p:cNvSpPr/>
            <p:nvPr/>
          </p:nvSpPr>
          <p:spPr>
            <a:xfrm>
              <a:off x="2645607" y="3630152"/>
              <a:ext cx="563155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Gapdh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직사각형 5"/>
            <p:cNvSpPr/>
            <p:nvPr/>
          </p:nvSpPr>
          <p:spPr>
            <a:xfrm>
              <a:off x="2657352" y="1666588"/>
              <a:ext cx="508323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2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직사각형 6"/>
            <p:cNvSpPr/>
            <p:nvPr/>
          </p:nvSpPr>
          <p:spPr>
            <a:xfrm>
              <a:off x="2657352" y="2670963"/>
              <a:ext cx="508323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5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" name="그림 8"/>
            <p:cNvPicPr>
              <a:picLocks noChangeAspect="1"/>
            </p:cNvPicPr>
            <p:nvPr/>
          </p:nvPicPr>
          <p:blipFill rotWithShape="1">
            <a:blip r:embed="rId2"/>
            <a:srcRect r="49925"/>
            <a:stretch/>
          </p:blipFill>
          <p:spPr>
            <a:xfrm>
              <a:off x="3341889" y="3616516"/>
              <a:ext cx="1620000" cy="42114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" name="Picture 3"/>
            <p:cNvPicPr>
              <a:picLocks noChangeAspect="1" noChangeArrowheads="1"/>
            </p:cNvPicPr>
            <p:nvPr/>
          </p:nvPicPr>
          <p:blipFill rotWithShape="1">
            <a:blip r:embed="rId3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118" r="50436" b="17983"/>
            <a:stretch/>
          </p:blipFill>
          <p:spPr bwMode="auto">
            <a:xfrm>
              <a:off x="3352511" y="3060087"/>
              <a:ext cx="1620000" cy="42720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1" name="Picture 11"/>
            <p:cNvPicPr>
              <a:picLocks noChangeAspect="1" noChangeArrowheads="1"/>
            </p:cNvPicPr>
            <p:nvPr/>
          </p:nvPicPr>
          <p:blipFill rotWithShape="1">
            <a:blip r:embed="rId4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596" t="10175" r="49380" b="15573"/>
            <a:stretch/>
          </p:blipFill>
          <p:spPr bwMode="auto">
            <a:xfrm>
              <a:off x="3352511" y="2576378"/>
              <a:ext cx="1620000" cy="435027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pic>
          <p:nvPicPr>
            <p:cNvPr id="12" name="Picture 12"/>
            <p:cNvPicPr>
              <a:picLocks noChangeAspect="1" noChangeArrowheads="1"/>
            </p:cNvPicPr>
            <p:nvPr/>
          </p:nvPicPr>
          <p:blipFill rotWithShape="1">
            <a:blip r:embed="rId5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857" t="9857" r="50827" b="24277"/>
            <a:stretch/>
          </p:blipFill>
          <p:spPr bwMode="auto">
            <a:xfrm>
              <a:off x="3352511" y="2078513"/>
              <a:ext cx="1620000" cy="449186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</a:extLst>
          </p:spPr>
        </p:pic>
        <p:cxnSp>
          <p:nvCxnSpPr>
            <p:cNvPr id="13" name="직선 연결선 12"/>
            <p:cNvCxnSpPr/>
            <p:nvPr/>
          </p:nvCxnSpPr>
          <p:spPr>
            <a:xfrm flipH="1">
              <a:off x="3358687" y="989007"/>
              <a:ext cx="800647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4" name="직선 연결선 13"/>
            <p:cNvCxnSpPr/>
            <p:nvPr/>
          </p:nvCxnSpPr>
          <p:spPr>
            <a:xfrm flipH="1">
              <a:off x="4234029" y="989007"/>
              <a:ext cx="727861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5" name="직선 연결선 14"/>
            <p:cNvCxnSpPr/>
            <p:nvPr/>
          </p:nvCxnSpPr>
          <p:spPr>
            <a:xfrm flipH="1">
              <a:off x="3359638" y="681925"/>
              <a:ext cx="1560235" cy="0"/>
            </a:xfrm>
            <a:prstGeom prst="line">
              <a:avLst/>
            </a:prstGeom>
            <a:ln w="1905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6" name="직사각형 15"/>
            <p:cNvSpPr/>
            <p:nvPr/>
          </p:nvSpPr>
          <p:spPr>
            <a:xfrm>
              <a:off x="3437545" y="404664"/>
              <a:ext cx="1414660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ko-K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vulated COCs (16 h)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092936" y="705304"/>
              <a:ext cx="1188132" cy="313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WT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4056074" y="706624"/>
              <a:ext cx="1080121" cy="31378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1</a:t>
              </a:r>
              <a:r>
                <a:rPr lang="en-US" altLang="ko-KR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K/O </a:t>
              </a:r>
            </a:p>
          </p:txBody>
        </p:sp>
        <p:sp>
          <p:nvSpPr>
            <p:cNvPr id="19" name="직사각형 18"/>
            <p:cNvSpPr/>
            <p:nvPr/>
          </p:nvSpPr>
          <p:spPr>
            <a:xfrm>
              <a:off x="2657352" y="3135190"/>
              <a:ext cx="508323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6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2657352" y="2163155"/>
              <a:ext cx="508323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4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2657352" y="1151680"/>
              <a:ext cx="508323" cy="31378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b="1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rdx1</a:t>
              </a:r>
              <a:endParaRPr lang="ko-KR" altLang="en-US" sz="1000" b="1" i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23" name="그림 22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52511" y="1037075"/>
              <a:ext cx="1620000" cy="503052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24" name="그림 23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52511" y="1588806"/>
              <a:ext cx="1620000" cy="43256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  <p:sp>
        <p:nvSpPr>
          <p:cNvPr id="25" name="직사각형 24"/>
          <p:cNvSpPr/>
          <p:nvPr/>
        </p:nvSpPr>
        <p:spPr>
          <a:xfrm>
            <a:off x="1626263" y="6457890"/>
            <a:ext cx="5613539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</a:t>
            </a:r>
            <a:endParaRPr lang="en-US" altLang="ko-KR" sz="1500" b="1" dirty="0">
              <a:solidFill>
                <a:srgbClr val="C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797362" y="206943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3527353" y="206942"/>
            <a:ext cx="324128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5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en-US" sz="15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직사각형 28"/>
          <p:cNvSpPr/>
          <p:nvPr/>
        </p:nvSpPr>
        <p:spPr>
          <a:xfrm>
            <a:off x="440772" y="4240639"/>
            <a:ext cx="8503920" cy="160043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 Changes in mRNA levels of </a:t>
            </a:r>
            <a:r>
              <a:rPr lang="en-US" altLang="ko-KR" sz="1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dxs</a:t>
            </a:r>
            <a:r>
              <a:rPr lang="ko-KR" alt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ily genes (</a:t>
            </a:r>
            <a:r>
              <a:rPr lang="en-US" altLang="ko-KR" sz="1400" b="1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dx</a:t>
            </a:r>
            <a:r>
              <a:rPr lang="en-US" altLang="ko-K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,2,4,5 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in ovulated COCs in WT and </a:t>
            </a:r>
            <a:r>
              <a:rPr lang="en-US" altLang="ko-KR" sz="14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dx1</a:t>
            </a:r>
            <a:r>
              <a:rPr lang="en-US" altLang="ko-KR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/O mice. </a:t>
            </a:r>
          </a:p>
          <a:p>
            <a:pPr algn="just"/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hanges of </a:t>
            </a:r>
            <a:r>
              <a:rPr lang="en-US" altLang="ko-KR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dxs</a:t>
            </a:r>
            <a:r>
              <a:rPr lang="ko-KR" alt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amily genes (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dx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,2,4,5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mRNA levels were confirmed in ovulated COCs by reverse transcription polymerase chain reaction (RT-PCR) analysis in 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dx1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K/O mice (A). The relative levels of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rdx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1 - 6 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RNA expression were obtained after normalization to </a:t>
            </a:r>
            <a:r>
              <a:rPr lang="en-US" altLang="ko-KR" sz="14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apdh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The histogram values of densitometry analysis were obtained using the Image J software. The bar graph data represent the least-squares means ± SEM of three independent experiments. *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, **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1, and ***</a:t>
            </a:r>
            <a:r>
              <a:rPr lang="en-US" altLang="ko-KR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ko-KR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01; t-test compared to WT mice.</a:t>
            </a:r>
            <a:endParaRPr lang="ko-KR" altLang="ko-KR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" name="개체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32569697"/>
              </p:ext>
            </p:extLst>
          </p:nvPr>
        </p:nvGraphicFramePr>
        <p:xfrm>
          <a:off x="3813175" y="842963"/>
          <a:ext cx="5003800" cy="25923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8" imgW="5004000" imgH="2592000" progId="Prism5.Document">
                  <p:embed/>
                </p:oleObj>
              </mc:Choice>
              <mc:Fallback>
                <p:oleObj name="Prism Project" r:id="rId8" imgW="5004000" imgH="2592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813175" y="842963"/>
                        <a:ext cx="5003800" cy="25923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7288661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8</TotalTime>
  <Words>156</Words>
  <Application>Microsoft Office PowerPoint</Application>
  <PresentationFormat>화면 슬라이드 쇼(4:3)</PresentationFormat>
  <Paragraphs>14</Paragraphs>
  <Slides>1</Slides>
  <Notes>0</Notes>
  <HiddenSlides>0</HiddenSlides>
  <MMClips>0</MMClips>
  <ScaleCrop>false</ScaleCrop>
  <HeadingPairs>
    <vt:vector size="8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포함된 OLE 서버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테마</vt:lpstr>
      <vt:lpstr>GraphPad Prism 5 Project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효진</dc:creator>
  <cp:lastModifiedBy>a</cp:lastModifiedBy>
  <cp:revision>10</cp:revision>
  <dcterms:created xsi:type="dcterms:W3CDTF">2018-01-24T02:09:55Z</dcterms:created>
  <dcterms:modified xsi:type="dcterms:W3CDTF">2021-07-27T03:51:24Z</dcterms:modified>
</cp:coreProperties>
</file>